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CF07C-38FE-458A-86B7-29252024D3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D85343-3FA5-407E-AAD5-FA359D0BF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44AA99-D487-4139-8070-6CE42B963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07162-E784-48C6-8A40-2B7EEB8E6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71B6A-C21A-46FE-B701-021B09FF7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8345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BA9EDD-D418-41EC-8D1F-C8854C9CE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3D0245-D9CA-4E1D-998D-704EA0E0E6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28BFA0-8AFB-4EAF-98BA-CEB019963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33126-04C6-4F69-98D2-EB80A68C4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E64455-0D54-47CB-B17B-B790B0834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85025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1E0054-E8CD-4CBE-950E-76D799275B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E4DB1E-B09A-4FC0-8344-AAB9D83EA4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17C2C3-0B20-4F6A-AD1C-8A8DDC015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BDEC1B-BD84-48FB-A1D0-0391180DB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CFFE82-1872-45ED-976C-559DA9E51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1467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07A2E-042D-4B41-A076-D88AB037B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E8830A-E227-4B9A-8132-A70A877E3F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F9A08-E8E8-44F5-AFC3-70D231290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C3EB2-448D-49CD-965E-E0E2B9586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65203-9C26-43C1-ADCB-3064739A6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4722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8F4EA6-6E1D-42CE-AE9D-141BAE7EF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FBE8ED-DF44-4E45-A1EF-6A77F3D787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7ED476-A143-4F30-9D69-D545ADE0F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32FC12-72DD-4561-B11A-09A5EB270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8FC17D-6982-4F44-84EA-96FC62FB3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3064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521EF5-271A-4547-87A9-F0A653246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F57522-0D87-457E-9AA9-391D6FCDCB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E66245-6D6A-42C0-ADB5-7C77F7C8E0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236EC0-65A0-46C7-B67B-05A40646D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B1115B-C160-4F58-A896-71436F6FD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2DB486-A750-492D-BF01-1457347D8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2709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7E9670-14E8-423A-86B1-8251594DE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47172E-C281-4F3E-8872-F5D1AC515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0B79EE-7C11-46B0-BCFB-FE98FE4F94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03F15A-6049-40C1-BE0C-14C170AB99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D60EFA-7415-434F-920A-69CD09F810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8A06A9-EF44-463F-A58F-BCB37586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88A126-50F4-4155-972F-4F7D3760E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CCBC89-A3D7-46E5-96C1-190D0EC1B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4885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E20FBF-BCD8-4635-BD9F-33264A3BE2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B56808-EC4E-4D49-836B-63C6842CD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FB45B4-6D8F-41B8-B4F7-D1A706F3D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AD6E4F-9558-4C95-9004-B162E1E9D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1007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1E318C-09A3-4E76-80AA-050CD2AC5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D0FD88-F78E-4C64-A115-DF15F59D1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B4D4E9-E43E-4DCD-8C2D-40F863EF3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541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0B5E71-29A7-40DF-82FD-F8119A709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106812-5175-468C-A35F-A38DB1BC37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9D10E8-A342-42C4-937A-33E77DF0DF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54C4E4-3127-4846-A389-47114A747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6C7ADC-CF06-458C-B58F-5216E8A7C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98F3F9-C316-4DDF-9D36-B7CD1307D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7276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0BB38-3A1C-4832-9B70-C511729EB4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BB9332-9CC4-4E59-AD0A-2134E4E15F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A5E897-CBAF-4D4E-8DF9-35FEA4F107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E56646-38FF-458A-B3ED-2133A73D7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061F71-DE58-4964-9468-28893DA8E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9028CA-6E20-498D-9AD2-AD65CADCF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4116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35DFE0-4430-4787-9F6C-83F1EBE196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CF12E5-DFC3-4333-809B-00574B45D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E809F6-1092-43F8-B11C-29859DCF74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2C922-1362-4606-8287-57C90D5B48CE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A2D8EF-D3AB-4E7C-9522-A442772108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2D7902-BFF8-4699-B850-50F6042234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89A2F-34A7-44DC-A3B2-116A1CA965B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84123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99FE60F-DF10-46D6-A308-6AEF8BEDA40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1" t="24757" r="19820" b="9725"/>
          <a:stretch/>
        </p:blipFill>
        <p:spPr>
          <a:xfrm>
            <a:off x="1426376" y="827711"/>
            <a:ext cx="3725754" cy="32706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FDBA23-6C46-4573-9683-100A6395C6BC}"/>
              </a:ext>
            </a:extLst>
          </p:cNvPr>
          <p:cNvSpPr txBox="1"/>
          <p:nvPr/>
        </p:nvSpPr>
        <p:spPr>
          <a:xfrm>
            <a:off x="4005492" y="0"/>
            <a:ext cx="4181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6 A representative uncropped imag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F20C44F-4938-4281-AA61-623EF3C0CE83}"/>
              </a:ext>
            </a:extLst>
          </p:cNvPr>
          <p:cNvSpPr txBox="1"/>
          <p:nvPr/>
        </p:nvSpPr>
        <p:spPr>
          <a:xfrm>
            <a:off x="2909977" y="573371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E448C63-4B99-4813-BD7A-C77AE5E6E837}"/>
              </a:ext>
            </a:extLst>
          </p:cNvPr>
          <p:cNvSpPr txBox="1"/>
          <p:nvPr/>
        </p:nvSpPr>
        <p:spPr>
          <a:xfrm>
            <a:off x="2501366" y="1239351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68EA13-E83B-4B60-A35C-CB93668C6B89}"/>
              </a:ext>
            </a:extLst>
          </p:cNvPr>
          <p:cNvSpPr txBox="1"/>
          <p:nvPr/>
        </p:nvSpPr>
        <p:spPr>
          <a:xfrm>
            <a:off x="3233142" y="1239351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CB1182-3E6B-41C2-8470-18CFF65CF82C}"/>
              </a:ext>
            </a:extLst>
          </p:cNvPr>
          <p:cNvSpPr txBox="1"/>
          <p:nvPr/>
        </p:nvSpPr>
        <p:spPr>
          <a:xfrm>
            <a:off x="3920888" y="1239351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A80E87-36CC-4700-912F-90E8B53E3234}"/>
              </a:ext>
            </a:extLst>
          </p:cNvPr>
          <p:cNvSpPr txBox="1"/>
          <p:nvPr/>
        </p:nvSpPr>
        <p:spPr>
          <a:xfrm>
            <a:off x="2867253" y="1239351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K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C49683D-96AE-4527-8B90-4258D774911F}"/>
              </a:ext>
            </a:extLst>
          </p:cNvPr>
          <p:cNvSpPr txBox="1"/>
          <p:nvPr/>
        </p:nvSpPr>
        <p:spPr>
          <a:xfrm>
            <a:off x="3566092" y="1235208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K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8CAE37-928B-458B-A88C-292470A87990}"/>
              </a:ext>
            </a:extLst>
          </p:cNvPr>
          <p:cNvSpPr txBox="1"/>
          <p:nvPr/>
        </p:nvSpPr>
        <p:spPr>
          <a:xfrm>
            <a:off x="4264931" y="1235208"/>
            <a:ext cx="503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K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0CFF5C-00F7-4637-AB87-040B979B159D}"/>
              </a:ext>
            </a:extLst>
          </p:cNvPr>
          <p:cNvSpPr txBox="1"/>
          <p:nvPr/>
        </p:nvSpPr>
        <p:spPr>
          <a:xfrm>
            <a:off x="8681591" y="573371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1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63925BA9-1329-4C9E-885D-844FFA0A12EC}"/>
              </a:ext>
            </a:extLst>
          </p:cNvPr>
          <p:cNvGrpSpPr/>
          <p:nvPr/>
        </p:nvGrpSpPr>
        <p:grpSpPr>
          <a:xfrm>
            <a:off x="7394631" y="827711"/>
            <a:ext cx="3220249" cy="3220249"/>
            <a:chOff x="7291846" y="827711"/>
            <a:chExt cx="3220249" cy="322024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AF71EF6-42F5-4BE6-8106-E05A59176D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1846" y="827711"/>
              <a:ext cx="3220249" cy="322024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C26449E-4A92-4E8A-B352-13C2B55D0AFE}"/>
                </a:ext>
              </a:extLst>
            </p:cNvPr>
            <p:cNvSpPr txBox="1"/>
            <p:nvPr/>
          </p:nvSpPr>
          <p:spPr>
            <a:xfrm>
              <a:off x="7634083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8839DD5-7D2F-4B96-BD83-970FE224A99E}"/>
                </a:ext>
              </a:extLst>
            </p:cNvPr>
            <p:cNvSpPr txBox="1"/>
            <p:nvPr/>
          </p:nvSpPr>
          <p:spPr>
            <a:xfrm>
              <a:off x="8186508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82A7467-7609-4B2B-BB12-2B6A07829E44}"/>
                </a:ext>
              </a:extLst>
            </p:cNvPr>
            <p:cNvSpPr txBox="1"/>
            <p:nvPr/>
          </p:nvSpPr>
          <p:spPr>
            <a:xfrm>
              <a:off x="8721435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4C2CBD2-B339-4BCE-98E6-3F852C931DE2}"/>
                </a:ext>
              </a:extLst>
            </p:cNvPr>
            <p:cNvSpPr txBox="1"/>
            <p:nvPr/>
          </p:nvSpPr>
          <p:spPr>
            <a:xfrm>
              <a:off x="7909476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2039410-CC34-4F9D-B8DB-598D0FF474E2}"/>
                </a:ext>
              </a:extLst>
            </p:cNvPr>
            <p:cNvSpPr txBox="1"/>
            <p:nvPr/>
          </p:nvSpPr>
          <p:spPr>
            <a:xfrm>
              <a:off x="8453972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2439C98-ED56-4998-AE8B-03E87DDDA8F2}"/>
                </a:ext>
              </a:extLst>
            </p:cNvPr>
            <p:cNvSpPr txBox="1"/>
            <p:nvPr/>
          </p:nvSpPr>
          <p:spPr>
            <a:xfrm>
              <a:off x="9004757" y="1235208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</p:grpSp>
      <p:pic>
        <p:nvPicPr>
          <p:cNvPr id="22" name="Picture 21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7F7E3FB1-3AA3-48D5-BD6D-45B4BD4A249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6" t="8671" r="7899" b="8118"/>
          <a:stretch/>
        </p:blipFill>
        <p:spPr>
          <a:xfrm>
            <a:off x="7687857" y="4244196"/>
            <a:ext cx="2630905" cy="261380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F845B106-905E-420C-A56D-8E49A0CAB816}"/>
              </a:ext>
            </a:extLst>
          </p:cNvPr>
          <p:cNvGrpSpPr/>
          <p:nvPr/>
        </p:nvGrpSpPr>
        <p:grpSpPr>
          <a:xfrm>
            <a:off x="1039642" y="4394979"/>
            <a:ext cx="4515536" cy="2463021"/>
            <a:chOff x="1039642" y="4394979"/>
            <a:chExt cx="4515536" cy="246302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00EC4D6-FBDD-4AA3-814D-957E0D56A1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0" t="33253" r="13411" b="16423"/>
            <a:stretch/>
          </p:blipFill>
          <p:spPr>
            <a:xfrm>
              <a:off x="1039642" y="4394979"/>
              <a:ext cx="4515536" cy="2463021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260AC4E-72F2-411C-9666-60042CD8DC41}"/>
                </a:ext>
              </a:extLst>
            </p:cNvPr>
            <p:cNvSpPr txBox="1"/>
            <p:nvPr/>
          </p:nvSpPr>
          <p:spPr>
            <a:xfrm>
              <a:off x="1538083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3F7F3F6-33D3-4F3B-921C-8D97DA8BF8D3}"/>
                </a:ext>
              </a:extLst>
            </p:cNvPr>
            <p:cNvSpPr txBox="1"/>
            <p:nvPr/>
          </p:nvSpPr>
          <p:spPr>
            <a:xfrm>
              <a:off x="2323770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ED48462-10DD-495B-86C0-2100C326136C}"/>
                </a:ext>
              </a:extLst>
            </p:cNvPr>
            <p:cNvSpPr txBox="1"/>
            <p:nvPr/>
          </p:nvSpPr>
          <p:spPr>
            <a:xfrm>
              <a:off x="3104887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1F0E887-0228-4435-8B6A-73B602669B82}"/>
                </a:ext>
              </a:extLst>
            </p:cNvPr>
            <p:cNvSpPr txBox="1"/>
            <p:nvPr/>
          </p:nvSpPr>
          <p:spPr>
            <a:xfrm>
              <a:off x="1928642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D0E5D84-3D03-4AF6-92B2-8330880381CA}"/>
                </a:ext>
              </a:extLst>
            </p:cNvPr>
            <p:cNvSpPr txBox="1"/>
            <p:nvPr/>
          </p:nvSpPr>
          <p:spPr>
            <a:xfrm>
              <a:off x="2708961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31AA9B5-7676-479D-8C60-9B756C56618D}"/>
                </a:ext>
              </a:extLst>
            </p:cNvPr>
            <p:cNvSpPr txBox="1"/>
            <p:nvPr/>
          </p:nvSpPr>
          <p:spPr>
            <a:xfrm>
              <a:off x="3494589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ECA9F5CB-4DE2-4786-A7B8-7BB792B76E67}"/>
              </a:ext>
            </a:extLst>
          </p:cNvPr>
          <p:cNvSpPr txBox="1"/>
          <p:nvPr/>
        </p:nvSpPr>
        <p:spPr>
          <a:xfrm>
            <a:off x="2704790" y="3971133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B9FBD9D-5B05-4D21-BF8A-8B3128E677D5}"/>
              </a:ext>
            </a:extLst>
          </p:cNvPr>
          <p:cNvSpPr txBox="1"/>
          <p:nvPr/>
        </p:nvSpPr>
        <p:spPr>
          <a:xfrm>
            <a:off x="8474957" y="3971133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A1384E6-1A07-4A2B-9E4A-62EFFB2448F2}"/>
              </a:ext>
            </a:extLst>
          </p:cNvPr>
          <p:cNvSpPr txBox="1"/>
          <p:nvPr/>
        </p:nvSpPr>
        <p:spPr>
          <a:xfrm>
            <a:off x="7843260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DDC93E9-35C7-4E81-9A87-6748554B0442}"/>
              </a:ext>
            </a:extLst>
          </p:cNvPr>
          <p:cNvSpPr txBox="1"/>
          <p:nvPr/>
        </p:nvSpPr>
        <p:spPr>
          <a:xfrm>
            <a:off x="8367795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423AA63-736F-4902-9441-87F1AC1D4578}"/>
              </a:ext>
            </a:extLst>
          </p:cNvPr>
          <p:cNvSpPr txBox="1"/>
          <p:nvPr/>
        </p:nvSpPr>
        <p:spPr>
          <a:xfrm>
            <a:off x="8907187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02C6D51-D93C-44FF-A354-7E9D9B25A6DF}"/>
              </a:ext>
            </a:extLst>
          </p:cNvPr>
          <p:cNvSpPr txBox="1"/>
          <p:nvPr/>
        </p:nvSpPr>
        <p:spPr>
          <a:xfrm>
            <a:off x="8095036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8D7A35B-3B53-4A96-BC43-80D49FB261C8}"/>
              </a:ext>
            </a:extLst>
          </p:cNvPr>
          <p:cNvSpPr txBox="1"/>
          <p:nvPr/>
        </p:nvSpPr>
        <p:spPr>
          <a:xfrm>
            <a:off x="8640725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658CBAE-435E-4721-B1B1-B8B98332B71F}"/>
              </a:ext>
            </a:extLst>
          </p:cNvPr>
          <p:cNvSpPr txBox="1"/>
          <p:nvPr/>
        </p:nvSpPr>
        <p:spPr>
          <a:xfrm>
            <a:off x="9158791" y="468704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3234931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C:\Users\broman2\AppData\Local\Microsoft\Windows\INetCache\Content.Word\BARBARA_IDH2_2018_04_14_131749AlexaFluor®488.tif">
            <a:extLst>
              <a:ext uri="{FF2B5EF4-FFF2-40B4-BE49-F238E27FC236}">
                <a16:creationId xmlns:a16="http://schemas.microsoft.com/office/drawing/2014/main" id="{33EDCC80-79FA-4790-99D1-ADA0A786AAD5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09" t="12268" r="16476" b="15064"/>
          <a:stretch/>
        </p:blipFill>
        <p:spPr bwMode="auto">
          <a:xfrm>
            <a:off x="1282460" y="902898"/>
            <a:ext cx="4026925" cy="320777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10A7B542-7186-4330-A221-0FFE6E8ED0E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3698" y="600333"/>
            <a:ext cx="3420728" cy="3420728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AEC956AE-E8D7-4BF2-842E-C742568003F1}"/>
              </a:ext>
            </a:extLst>
          </p:cNvPr>
          <p:cNvGrpSpPr/>
          <p:nvPr/>
        </p:nvGrpSpPr>
        <p:grpSpPr>
          <a:xfrm>
            <a:off x="1039642" y="4394979"/>
            <a:ext cx="4515536" cy="2463021"/>
            <a:chOff x="1039642" y="4394979"/>
            <a:chExt cx="4515536" cy="246302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A4F9DF4-514D-45A6-8198-954A37F4F8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0" t="33253" r="13411" b="16423"/>
            <a:stretch/>
          </p:blipFill>
          <p:spPr>
            <a:xfrm>
              <a:off x="1039642" y="4394979"/>
              <a:ext cx="4515536" cy="246302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5EF670-2926-4C37-AB9C-A0DA94FAE082}"/>
                </a:ext>
              </a:extLst>
            </p:cNvPr>
            <p:cNvSpPr txBox="1"/>
            <p:nvPr/>
          </p:nvSpPr>
          <p:spPr>
            <a:xfrm>
              <a:off x="1538083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885077D-00BE-4488-9A61-25B821B5FCB9}"/>
                </a:ext>
              </a:extLst>
            </p:cNvPr>
            <p:cNvSpPr txBox="1"/>
            <p:nvPr/>
          </p:nvSpPr>
          <p:spPr>
            <a:xfrm>
              <a:off x="2323770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9A0ECEB-E32E-4CBB-97EA-35C3C0AAEFFB}"/>
                </a:ext>
              </a:extLst>
            </p:cNvPr>
            <p:cNvSpPr txBox="1"/>
            <p:nvPr/>
          </p:nvSpPr>
          <p:spPr>
            <a:xfrm>
              <a:off x="3104887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W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7870C1-8397-4AAC-ADCF-187DE48111B5}"/>
                </a:ext>
              </a:extLst>
            </p:cNvPr>
            <p:cNvSpPr txBox="1"/>
            <p:nvPr/>
          </p:nvSpPr>
          <p:spPr>
            <a:xfrm>
              <a:off x="1928642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F97E95-A099-4758-AF83-EAEF24632D2D}"/>
                </a:ext>
              </a:extLst>
            </p:cNvPr>
            <p:cNvSpPr txBox="1"/>
            <p:nvPr/>
          </p:nvSpPr>
          <p:spPr>
            <a:xfrm>
              <a:off x="2708961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C2126BB-E5BF-49AA-B506-88C86A4C9348}"/>
                </a:ext>
              </a:extLst>
            </p:cNvPr>
            <p:cNvSpPr txBox="1"/>
            <p:nvPr/>
          </p:nvSpPr>
          <p:spPr>
            <a:xfrm>
              <a:off x="3494589" y="4687041"/>
              <a:ext cx="5032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Ko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F9A395F5-EFDD-4092-AB07-23A56BB32C67}"/>
              </a:ext>
            </a:extLst>
          </p:cNvPr>
          <p:cNvSpPr txBox="1"/>
          <p:nvPr/>
        </p:nvSpPr>
        <p:spPr>
          <a:xfrm>
            <a:off x="2699581" y="4021061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B10615-090E-4B42-914C-B0B0D8C22C0A}"/>
              </a:ext>
            </a:extLst>
          </p:cNvPr>
          <p:cNvSpPr txBox="1"/>
          <p:nvPr/>
        </p:nvSpPr>
        <p:spPr>
          <a:xfrm>
            <a:off x="2199579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5E1D2AB-68FB-4ADF-8DBF-F3802399833C}"/>
              </a:ext>
            </a:extLst>
          </p:cNvPr>
          <p:cNvSpPr txBox="1"/>
          <p:nvPr/>
        </p:nvSpPr>
        <p:spPr>
          <a:xfrm>
            <a:off x="2853282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7AFC56-8D8B-4CAE-A5EA-19FFEC093E40}"/>
              </a:ext>
            </a:extLst>
          </p:cNvPr>
          <p:cNvSpPr txBox="1"/>
          <p:nvPr/>
        </p:nvSpPr>
        <p:spPr>
          <a:xfrm>
            <a:off x="3516427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87DB50-22B2-4941-BEA0-1F1D14DA695A}"/>
              </a:ext>
            </a:extLst>
          </p:cNvPr>
          <p:cNvSpPr txBox="1"/>
          <p:nvPr/>
        </p:nvSpPr>
        <p:spPr>
          <a:xfrm>
            <a:off x="2531152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AF8AC02-F69C-4885-A506-312404CD9E0F}"/>
              </a:ext>
            </a:extLst>
          </p:cNvPr>
          <p:cNvSpPr txBox="1"/>
          <p:nvPr/>
        </p:nvSpPr>
        <p:spPr>
          <a:xfrm>
            <a:off x="3212170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CEBCA54-BF3A-4AC2-9497-7B2ABF961772}"/>
              </a:ext>
            </a:extLst>
          </p:cNvPr>
          <p:cNvSpPr txBox="1"/>
          <p:nvPr/>
        </p:nvSpPr>
        <p:spPr>
          <a:xfrm>
            <a:off x="8482292" y="3901896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  <p:pic>
        <p:nvPicPr>
          <p:cNvPr id="23" name="Picture 22" descr="A picture containing oven&#10;&#10;Description automatically generated">
            <a:extLst>
              <a:ext uri="{FF2B5EF4-FFF2-40B4-BE49-F238E27FC236}">
                <a16:creationId xmlns:a16="http://schemas.microsoft.com/office/drawing/2014/main" id="{79D5ECF6-012C-4459-8179-76CFCC2BABD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9" t="10879" r="6790" b="9676"/>
          <a:stretch/>
        </p:blipFill>
        <p:spPr>
          <a:xfrm>
            <a:off x="7484311" y="4166558"/>
            <a:ext cx="3059502" cy="269144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0E586B8-7E71-4D4E-806B-399F6F8C7987}"/>
              </a:ext>
            </a:extLst>
          </p:cNvPr>
          <p:cNvSpPr txBox="1"/>
          <p:nvPr/>
        </p:nvSpPr>
        <p:spPr>
          <a:xfrm>
            <a:off x="8557109" y="946803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EDE4FA0-958A-48FD-AAAA-04809E47E3D7}"/>
              </a:ext>
            </a:extLst>
          </p:cNvPr>
          <p:cNvSpPr txBox="1"/>
          <p:nvPr/>
        </p:nvSpPr>
        <p:spPr>
          <a:xfrm>
            <a:off x="9137558" y="94680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9F4C62E-D74C-4E35-A3B7-DD82B7F4F8A3}"/>
              </a:ext>
            </a:extLst>
          </p:cNvPr>
          <p:cNvSpPr txBox="1"/>
          <p:nvPr/>
        </p:nvSpPr>
        <p:spPr>
          <a:xfrm>
            <a:off x="9718007" y="946801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405586E-ED3B-4066-BD9A-FE96221A46D5}"/>
              </a:ext>
            </a:extLst>
          </p:cNvPr>
          <p:cNvSpPr txBox="1"/>
          <p:nvPr/>
        </p:nvSpPr>
        <p:spPr>
          <a:xfrm>
            <a:off x="8266885" y="94680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E5FB4D5-1610-4E1E-AEB4-D067E8FB8A8F}"/>
              </a:ext>
            </a:extLst>
          </p:cNvPr>
          <p:cNvSpPr txBox="1"/>
          <p:nvPr/>
        </p:nvSpPr>
        <p:spPr>
          <a:xfrm>
            <a:off x="8847333" y="94364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2793572-B6CA-4E98-8C9B-CCA2879FECB7}"/>
              </a:ext>
            </a:extLst>
          </p:cNvPr>
          <p:cNvSpPr txBox="1"/>
          <p:nvPr/>
        </p:nvSpPr>
        <p:spPr>
          <a:xfrm>
            <a:off x="9426967" y="94364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44230F-8CAF-4080-8722-82DC2632067D}"/>
              </a:ext>
            </a:extLst>
          </p:cNvPr>
          <p:cNvSpPr txBox="1"/>
          <p:nvPr/>
        </p:nvSpPr>
        <p:spPr>
          <a:xfrm>
            <a:off x="2909976" y="573371"/>
            <a:ext cx="646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A28BBFC-64DF-493F-A63A-E428B66FCA26}"/>
              </a:ext>
            </a:extLst>
          </p:cNvPr>
          <p:cNvSpPr txBox="1"/>
          <p:nvPr/>
        </p:nvSpPr>
        <p:spPr>
          <a:xfrm>
            <a:off x="8681590" y="573371"/>
            <a:ext cx="646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D2D5E46-0409-4DE7-B60A-55F046520530}"/>
              </a:ext>
            </a:extLst>
          </p:cNvPr>
          <p:cNvSpPr txBox="1"/>
          <p:nvPr/>
        </p:nvSpPr>
        <p:spPr>
          <a:xfrm>
            <a:off x="4005492" y="0"/>
            <a:ext cx="4181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6 B representative uncropped imag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02CE64B-FB26-4DDF-8B52-7D20EA3112F5}"/>
              </a:ext>
            </a:extLst>
          </p:cNvPr>
          <p:cNvSpPr txBox="1"/>
          <p:nvPr/>
        </p:nvSpPr>
        <p:spPr>
          <a:xfrm>
            <a:off x="8334164" y="4390393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45FE284-CD1E-4E5B-97AD-39FD20BAB46E}"/>
              </a:ext>
            </a:extLst>
          </p:cNvPr>
          <p:cNvSpPr txBox="1"/>
          <p:nvPr/>
        </p:nvSpPr>
        <p:spPr>
          <a:xfrm>
            <a:off x="8888335" y="4394977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A747CF0-EE71-4998-A5AA-FB7A888CE98A}"/>
              </a:ext>
            </a:extLst>
          </p:cNvPr>
          <p:cNvSpPr txBox="1"/>
          <p:nvPr/>
        </p:nvSpPr>
        <p:spPr>
          <a:xfrm>
            <a:off x="9466402" y="4390393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Ko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22281BD-1EEC-473E-A52E-E26A7579F5CB}"/>
              </a:ext>
            </a:extLst>
          </p:cNvPr>
          <p:cNvSpPr txBox="1"/>
          <p:nvPr/>
        </p:nvSpPr>
        <p:spPr>
          <a:xfrm>
            <a:off x="8608977" y="439180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0D29A0D-2321-4C52-99A1-9B38F5A7C00F}"/>
              </a:ext>
            </a:extLst>
          </p:cNvPr>
          <p:cNvSpPr txBox="1"/>
          <p:nvPr/>
        </p:nvSpPr>
        <p:spPr>
          <a:xfrm>
            <a:off x="9182238" y="4386015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48A452D-FAFE-4F35-996A-4C1D1CC98A2A}"/>
              </a:ext>
            </a:extLst>
          </p:cNvPr>
          <p:cNvSpPr txBox="1"/>
          <p:nvPr/>
        </p:nvSpPr>
        <p:spPr>
          <a:xfrm>
            <a:off x="9753502" y="4394977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16EC193-FD2C-49BD-B678-E2B1CEE98550}"/>
              </a:ext>
            </a:extLst>
          </p:cNvPr>
          <p:cNvSpPr txBox="1"/>
          <p:nvPr/>
        </p:nvSpPr>
        <p:spPr>
          <a:xfrm>
            <a:off x="3881336" y="1308361"/>
            <a:ext cx="503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Ko</a:t>
            </a:r>
          </a:p>
        </p:txBody>
      </p:sp>
    </p:spTree>
    <p:extLst>
      <p:ext uri="{BB962C8B-B14F-4D97-AF65-F5344CB8AC3E}">
        <p14:creationId xmlns:p14="http://schemas.microsoft.com/office/powerpoint/2010/main" val="177782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5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 Boppana</dc:creator>
  <cp:lastModifiedBy>Srinivas Boppana</cp:lastModifiedBy>
  <cp:revision>3</cp:revision>
  <dcterms:created xsi:type="dcterms:W3CDTF">2021-12-01T02:11:00Z</dcterms:created>
  <dcterms:modified xsi:type="dcterms:W3CDTF">2021-12-01T07:27:25Z</dcterms:modified>
</cp:coreProperties>
</file>